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4A61032-518A-4E54-8022-AB1E5DC6BF4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2D79174-EFB1-409C-8CE0-D9276C1CF62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BEBAD11-E130-4896-BBBD-980AEE44EE2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EF4ABEF-BAF8-49C6-BC0C-E450C68BC0B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A152725-314F-4C5A-A3E9-8AA831910D3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C10EE22-370A-4AE0-821F-12CB12AE48C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2C80960-E673-46D8-B58E-F57A24B4E09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80306DF-87CD-448F-9F88-D49AC6449D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DBA8C16-6450-46D5-8D35-A0A2F52408C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D9C54E0-4297-4FA1-82AD-90193DEFC9A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60FF2A1-3B5C-4F75-B7EB-7B3D809D341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7C80797-5325-4279-BC3E-1F5272B8C6A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95D091B-0D46-4721-95AA-55B5DE60E345}"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3"/>
          <p:cNvSpPr/>
          <p:nvPr/>
        </p:nvSpPr>
        <p:spPr>
          <a:xfrm>
            <a:off x="2286000" y="474840"/>
            <a:ext cx="4572000" cy="5854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ppendix 1:  Needs Assessment Tool</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u="sng">
                <a:solidFill>
                  <a:srgbClr val="000000"/>
                </a:solidFill>
                <a:uFillTx/>
                <a:latin typeface="Calibri"/>
              </a:rPr>
              <a:t>Practical/Access</a:t>
            </a:r>
            <a:r>
              <a:rPr b="0" lang="en-US" sz="1800" spc="-1" strike="noStrike">
                <a:solidFill>
                  <a:srgbClr val="000000"/>
                </a:solidFill>
                <a:latin typeface="Calibri"/>
              </a:rPr>
              <a:t>:</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ometimes women are concerned with the way they are going to pay for and get to treatment for their breast cancer. Are these things you would like to know more about?</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 </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u="sng">
                <a:solidFill>
                  <a:srgbClr val="000000"/>
                </a:solidFill>
                <a:uFillTx/>
                <a:latin typeface="Calibri"/>
              </a:rPr>
              <a:t>Information</a:t>
            </a:r>
            <a:r>
              <a:rPr b="0" lang="en-US" sz="1800" spc="-1" strike="noStrike">
                <a:solidFill>
                  <a:srgbClr val="000000"/>
                </a:solidFill>
                <a:latin typeface="Calibri"/>
              </a:rPr>
              <a:t>:</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ometimes women need help understanding what breast cancer is and how it's treated. Would you like more information about breast cancer and treatment?</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 </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u="sng">
                <a:solidFill>
                  <a:srgbClr val="000000"/>
                </a:solidFill>
                <a:uFillTx/>
                <a:latin typeface="Calibri"/>
              </a:rPr>
              <a:t>Psychosocial/Emotional</a:t>
            </a:r>
            <a:r>
              <a:rPr b="0" lang="en-US" sz="1800" spc="-1" strike="noStrike">
                <a:solidFill>
                  <a:srgbClr val="000000"/>
                </a:solidFill>
                <a:latin typeface="Calibri"/>
              </a:rPr>
              <a:t>:</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ometimes women are concerned about what it means to have breast cancer or how to deal with a breast cancer diagnosis. Is this something that concerns you? Would you be interested in finding out about organizations that provide support to individuals and groups, or offer support groups or counseling?</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9-26T01:08:24Z</dcterms:created>
  <dc:creator>anne  stey</dc:creator>
  <dc:description/>
  <dc:language>en-US</dc:language>
  <cp:lastModifiedBy>Maledeo, Rhea M.</cp:lastModifiedBy>
  <dcterms:modified xsi:type="dcterms:W3CDTF">2013-03-06T09:10:47Z</dcterms:modified>
  <cp:revision>1</cp:revision>
  <dc:subject/>
  <dc:title>PowerPoint Presentation</dc:title>
</cp:coreProperties>
</file>